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89" r:id="rId2"/>
    <p:sldId id="288" r:id="rId3"/>
  </p:sldIdLst>
  <p:sldSz cx="12192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000"/>
    <a:srgbClr val="0000FF"/>
    <a:srgbClr val="E3AE02"/>
    <a:srgbClr val="02C60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60" autoAdjust="0"/>
    <p:restoredTop sz="91114" autoAdjust="0"/>
  </p:normalViewPr>
  <p:slideViewPr>
    <p:cSldViewPr snapToGrid="0">
      <p:cViewPr varScale="1">
        <p:scale>
          <a:sx n="80" d="100"/>
          <a:sy n="80" d="100"/>
        </p:scale>
        <p:origin x="21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C0058D-EC08-4916-87A5-4F6E119EC237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38263" y="1143000"/>
            <a:ext cx="4181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F48480-4BE8-458B-AD80-41053740409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518920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ZA"/>
              <a:t>Figure </a:t>
            </a:r>
            <a:r>
              <a:rPr lang="en-ZA" dirty="0"/>
              <a:t>S2: Western blot analysis of relative A) LC3 and B) p62 abundance levels of GT1-7 cells treated for 24 hrs of 100 µM (HME) and 50 µM (LME) of memantine and 48 hours with 100 µM (HML) and 50 µM (LML) of memantine. n=3. *p&lt;0,05. </a:t>
            </a:r>
          </a:p>
          <a:p>
            <a:r>
              <a:rPr lang="en-ZA" dirty="0"/>
              <a:t>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F48480-4BE8-458B-AD80-410537404097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19722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ZA" dirty="0"/>
              <a:t>Figure S1: GFP-LC3 and </a:t>
            </a:r>
            <a:r>
              <a:rPr lang="en-ZA" dirty="0" err="1"/>
              <a:t>LysoTracker</a:t>
            </a:r>
            <a:r>
              <a:rPr lang="en-ZA" dirty="0"/>
              <a:t> Red were not successful in indicating autophagy following CCCP and </a:t>
            </a:r>
            <a:r>
              <a:rPr lang="en-ZA" dirty="0" err="1"/>
              <a:t>Baf</a:t>
            </a:r>
            <a:r>
              <a:rPr lang="en-ZA" dirty="0"/>
              <a:t> treatment, either separately or in combination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F48480-4BE8-458B-AD80-410537404097}" type="slidenum">
              <a:rPr lang="en-ZA" smtClean="0"/>
              <a:t>2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552220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2842"/>
            <a:ext cx="1036320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26842"/>
            <a:ext cx="9144000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08729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76329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79142"/>
            <a:ext cx="2628900" cy="762669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79142"/>
            <a:ext cx="7734300" cy="762669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91188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65102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3638"/>
            <a:ext cx="1051560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22610"/>
            <a:ext cx="1051560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58427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95710"/>
            <a:ext cx="5181600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95710"/>
            <a:ext cx="5181600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36684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79144"/>
            <a:ext cx="10515600" cy="17394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06137"/>
            <a:ext cx="5157787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87331"/>
            <a:ext cx="5157787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06137"/>
            <a:ext cx="518318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87331"/>
            <a:ext cx="5183188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88403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01911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83251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5769"/>
            <a:ext cx="6172200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77973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5769"/>
            <a:ext cx="6172200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96669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79144"/>
            <a:ext cx="105156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95710"/>
            <a:ext cx="105156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152CA-6927-46A0-B4D8-E4CAFFE4AE2D}" type="datetimeFigureOut">
              <a:rPr lang="en-ZA" smtClean="0"/>
              <a:t>2023/06/27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41240"/>
            <a:ext cx="41148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9F51C-0C7A-429D-81BD-4202E92AEBD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95572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720C706-7654-11EC-BCA3-1EB35B3EA5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97020" y="775237"/>
            <a:ext cx="4168708" cy="361409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759F5EC-FDE9-32EE-20A9-A77E475A370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7980" y="635309"/>
            <a:ext cx="4383404" cy="361524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98027AE-35F8-8097-FDDE-1B6249C92B34}"/>
              </a:ext>
            </a:extLst>
          </p:cNvPr>
          <p:cNvSpPr txBox="1"/>
          <p:nvPr/>
        </p:nvSpPr>
        <p:spPr>
          <a:xfrm>
            <a:off x="1930729" y="4448863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Con</a:t>
            </a:r>
            <a:endParaRPr lang="en-ZA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6177E5-CC25-D9AA-0F44-64A00F757FF4}"/>
              </a:ext>
            </a:extLst>
          </p:cNvPr>
          <p:cNvSpPr txBox="1"/>
          <p:nvPr/>
        </p:nvSpPr>
        <p:spPr>
          <a:xfrm>
            <a:off x="2498207" y="4448863"/>
            <a:ext cx="4619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HME</a:t>
            </a:r>
            <a:endParaRPr lang="en-ZA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4D1ED01-B80C-E1BE-8439-22644258E2D4}"/>
              </a:ext>
            </a:extLst>
          </p:cNvPr>
          <p:cNvSpPr txBox="1"/>
          <p:nvPr/>
        </p:nvSpPr>
        <p:spPr>
          <a:xfrm>
            <a:off x="3069682" y="4448863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HML</a:t>
            </a:r>
            <a:endParaRPr lang="en-ZA" dirty="0"/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4A24A34-E8F0-1D24-B415-46D18F158763}"/>
              </a:ext>
            </a:extLst>
          </p:cNvPr>
          <p:cNvCxnSpPr>
            <a:cxnSpLocks/>
          </p:cNvCxnSpPr>
          <p:nvPr/>
        </p:nvCxnSpPr>
        <p:spPr>
          <a:xfrm>
            <a:off x="1940995" y="4715530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58DAF6E-89A3-6CDA-B192-8D70C5AB4E9F}"/>
              </a:ext>
            </a:extLst>
          </p:cNvPr>
          <p:cNvCxnSpPr>
            <a:cxnSpLocks/>
          </p:cNvCxnSpPr>
          <p:nvPr/>
        </p:nvCxnSpPr>
        <p:spPr>
          <a:xfrm>
            <a:off x="2538689" y="4715530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07CA93E-AB96-AE0C-B2CC-C1CAEFCEB6AC}"/>
              </a:ext>
            </a:extLst>
          </p:cNvPr>
          <p:cNvCxnSpPr>
            <a:cxnSpLocks/>
          </p:cNvCxnSpPr>
          <p:nvPr/>
        </p:nvCxnSpPr>
        <p:spPr>
          <a:xfrm>
            <a:off x="3095901" y="4715530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57C8AF7-4AB8-F8BD-A076-5B0BF7BBE699}"/>
              </a:ext>
            </a:extLst>
          </p:cNvPr>
          <p:cNvCxnSpPr>
            <a:cxnSpLocks/>
          </p:cNvCxnSpPr>
          <p:nvPr/>
        </p:nvCxnSpPr>
        <p:spPr>
          <a:xfrm>
            <a:off x="3700627" y="4715530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E298A69C-CB66-45F7-D742-613173E2EFC6}"/>
              </a:ext>
            </a:extLst>
          </p:cNvPr>
          <p:cNvCxnSpPr>
            <a:cxnSpLocks/>
          </p:cNvCxnSpPr>
          <p:nvPr/>
        </p:nvCxnSpPr>
        <p:spPr>
          <a:xfrm>
            <a:off x="4292505" y="4715530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E669A64F-3F4B-BA8E-484D-69A3CA370CCD}"/>
              </a:ext>
            </a:extLst>
          </p:cNvPr>
          <p:cNvSpPr txBox="1"/>
          <p:nvPr/>
        </p:nvSpPr>
        <p:spPr>
          <a:xfrm>
            <a:off x="3683330" y="4460565"/>
            <a:ext cx="4331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LME</a:t>
            </a:r>
            <a:endParaRPr lang="en-ZA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48B2E19-E029-57C2-F2CF-E0BD48109361}"/>
              </a:ext>
            </a:extLst>
          </p:cNvPr>
          <p:cNvSpPr txBox="1"/>
          <p:nvPr/>
        </p:nvSpPr>
        <p:spPr>
          <a:xfrm>
            <a:off x="4274224" y="4460565"/>
            <a:ext cx="4235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LML</a:t>
            </a:r>
            <a:endParaRPr lang="en-ZA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EC7ED1C-6B26-78AF-157A-F59F5E721796}"/>
              </a:ext>
            </a:extLst>
          </p:cNvPr>
          <p:cNvSpPr txBox="1"/>
          <p:nvPr/>
        </p:nvSpPr>
        <p:spPr>
          <a:xfrm>
            <a:off x="1262916" y="4833256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 err="1"/>
              <a:t>Baf</a:t>
            </a:r>
            <a:endParaRPr lang="en-ZA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234E731-8F0B-885C-C27F-8B2348856CBF}"/>
              </a:ext>
            </a:extLst>
          </p:cNvPr>
          <p:cNvSpPr txBox="1"/>
          <p:nvPr/>
        </p:nvSpPr>
        <p:spPr>
          <a:xfrm>
            <a:off x="1900138" y="4831327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7AEE89E-4EA6-C2F4-458E-652BFCECCD90}"/>
              </a:ext>
            </a:extLst>
          </p:cNvPr>
          <p:cNvSpPr txBox="1"/>
          <p:nvPr/>
        </p:nvSpPr>
        <p:spPr>
          <a:xfrm>
            <a:off x="2162046" y="4833256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213E5B7-71E1-B9EA-EA8B-F054C7D151F9}"/>
              </a:ext>
            </a:extLst>
          </p:cNvPr>
          <p:cNvSpPr txBox="1"/>
          <p:nvPr/>
        </p:nvSpPr>
        <p:spPr>
          <a:xfrm>
            <a:off x="2467616" y="4831327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EB7EDA4-99EA-557D-7599-09EF0C2EA381}"/>
              </a:ext>
            </a:extLst>
          </p:cNvPr>
          <p:cNvSpPr txBox="1"/>
          <p:nvPr/>
        </p:nvSpPr>
        <p:spPr>
          <a:xfrm>
            <a:off x="2729524" y="4833256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AD87BF9-A280-5B4F-A78D-CF68EF07B148}"/>
              </a:ext>
            </a:extLst>
          </p:cNvPr>
          <p:cNvSpPr txBox="1"/>
          <p:nvPr/>
        </p:nvSpPr>
        <p:spPr>
          <a:xfrm>
            <a:off x="3035094" y="4829398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A460E14-ED5F-701B-F9BF-5DDB7B808390}"/>
              </a:ext>
            </a:extLst>
          </p:cNvPr>
          <p:cNvSpPr txBox="1"/>
          <p:nvPr/>
        </p:nvSpPr>
        <p:spPr>
          <a:xfrm>
            <a:off x="3297002" y="4831327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3B90EDE-1EC4-106B-0C10-07545A65F50F}"/>
              </a:ext>
            </a:extLst>
          </p:cNvPr>
          <p:cNvSpPr txBox="1"/>
          <p:nvPr/>
        </p:nvSpPr>
        <p:spPr>
          <a:xfrm>
            <a:off x="3595892" y="4821682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69CF3D1-637E-1417-A57F-AFB1D6A56D10}"/>
              </a:ext>
            </a:extLst>
          </p:cNvPr>
          <p:cNvSpPr txBox="1"/>
          <p:nvPr/>
        </p:nvSpPr>
        <p:spPr>
          <a:xfrm>
            <a:off x="3857800" y="4823611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907D8C7-949C-4889-145C-5420B89D9DFC}"/>
              </a:ext>
            </a:extLst>
          </p:cNvPr>
          <p:cNvSpPr txBox="1"/>
          <p:nvPr/>
        </p:nvSpPr>
        <p:spPr>
          <a:xfrm>
            <a:off x="4193482" y="4821562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DCE1D76-FA01-739E-9BE2-DF558CBECE64}"/>
              </a:ext>
            </a:extLst>
          </p:cNvPr>
          <p:cNvSpPr txBox="1"/>
          <p:nvPr/>
        </p:nvSpPr>
        <p:spPr>
          <a:xfrm>
            <a:off x="4455390" y="4823491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F484A10-0B8B-35F4-6F29-3CF204656BDA}"/>
              </a:ext>
            </a:extLst>
          </p:cNvPr>
          <p:cNvSpPr txBox="1"/>
          <p:nvPr/>
        </p:nvSpPr>
        <p:spPr>
          <a:xfrm>
            <a:off x="7777009" y="4450720"/>
            <a:ext cx="4074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Con</a:t>
            </a:r>
            <a:endParaRPr lang="en-ZA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EAC7762-6A42-73D0-3FA2-4F02EEF1D5A5}"/>
              </a:ext>
            </a:extLst>
          </p:cNvPr>
          <p:cNvSpPr txBox="1"/>
          <p:nvPr/>
        </p:nvSpPr>
        <p:spPr>
          <a:xfrm>
            <a:off x="8344487" y="4450720"/>
            <a:ext cx="4619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HME</a:t>
            </a:r>
            <a:endParaRPr lang="en-ZA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466C999-480D-50F0-5179-945AF22C5744}"/>
              </a:ext>
            </a:extLst>
          </p:cNvPr>
          <p:cNvSpPr txBox="1"/>
          <p:nvPr/>
        </p:nvSpPr>
        <p:spPr>
          <a:xfrm>
            <a:off x="8915962" y="4450720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HML</a:t>
            </a:r>
            <a:endParaRPr lang="en-ZA" dirty="0"/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99ACBB2B-449D-364F-1340-BA99C7CBC3F6}"/>
              </a:ext>
            </a:extLst>
          </p:cNvPr>
          <p:cNvCxnSpPr>
            <a:cxnSpLocks/>
          </p:cNvCxnSpPr>
          <p:nvPr/>
        </p:nvCxnSpPr>
        <p:spPr>
          <a:xfrm>
            <a:off x="7787275" y="4717387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0F6ED1B7-FCE2-93D3-EDE5-06AF92DC844C}"/>
              </a:ext>
            </a:extLst>
          </p:cNvPr>
          <p:cNvCxnSpPr>
            <a:cxnSpLocks/>
          </p:cNvCxnSpPr>
          <p:nvPr/>
        </p:nvCxnSpPr>
        <p:spPr>
          <a:xfrm>
            <a:off x="8384969" y="4717387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3C7EACF4-0014-E2EC-137C-23D65456BCE4}"/>
              </a:ext>
            </a:extLst>
          </p:cNvPr>
          <p:cNvCxnSpPr>
            <a:cxnSpLocks/>
          </p:cNvCxnSpPr>
          <p:nvPr/>
        </p:nvCxnSpPr>
        <p:spPr>
          <a:xfrm>
            <a:off x="8942181" y="4717387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3050978C-E06C-15D1-ED32-A9FF74D785A3}"/>
              </a:ext>
            </a:extLst>
          </p:cNvPr>
          <p:cNvCxnSpPr>
            <a:cxnSpLocks/>
          </p:cNvCxnSpPr>
          <p:nvPr/>
        </p:nvCxnSpPr>
        <p:spPr>
          <a:xfrm>
            <a:off x="9546907" y="4717387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5D7B5A14-8674-2B7F-A04D-8D67CD27E86F}"/>
              </a:ext>
            </a:extLst>
          </p:cNvPr>
          <p:cNvCxnSpPr>
            <a:cxnSpLocks/>
          </p:cNvCxnSpPr>
          <p:nvPr/>
        </p:nvCxnSpPr>
        <p:spPr>
          <a:xfrm>
            <a:off x="10138785" y="4717387"/>
            <a:ext cx="3869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42C157D0-B42B-BD87-48E8-B90A51EE991E}"/>
              </a:ext>
            </a:extLst>
          </p:cNvPr>
          <p:cNvSpPr txBox="1"/>
          <p:nvPr/>
        </p:nvSpPr>
        <p:spPr>
          <a:xfrm>
            <a:off x="9529610" y="4462422"/>
            <a:ext cx="4331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LME</a:t>
            </a:r>
            <a:endParaRPr lang="en-ZA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FA41515-3A72-CDFC-7F19-F01BACA74EF1}"/>
              </a:ext>
            </a:extLst>
          </p:cNvPr>
          <p:cNvSpPr txBox="1"/>
          <p:nvPr/>
        </p:nvSpPr>
        <p:spPr>
          <a:xfrm>
            <a:off x="10120504" y="4462422"/>
            <a:ext cx="4235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LML</a:t>
            </a:r>
            <a:endParaRPr lang="en-ZA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ED38822-7FC8-ADF4-E7DC-254E8194E607}"/>
              </a:ext>
            </a:extLst>
          </p:cNvPr>
          <p:cNvSpPr txBox="1"/>
          <p:nvPr/>
        </p:nvSpPr>
        <p:spPr>
          <a:xfrm>
            <a:off x="7109196" y="4835113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 err="1"/>
              <a:t>Baf</a:t>
            </a:r>
            <a:endParaRPr lang="en-ZA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85DB659-1265-1A70-CF9B-0AF190401B2E}"/>
              </a:ext>
            </a:extLst>
          </p:cNvPr>
          <p:cNvSpPr txBox="1"/>
          <p:nvPr/>
        </p:nvSpPr>
        <p:spPr>
          <a:xfrm>
            <a:off x="7746418" y="4833184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1FEEC86-2F3C-4DFE-D9DB-705B2D027B19}"/>
              </a:ext>
            </a:extLst>
          </p:cNvPr>
          <p:cNvSpPr txBox="1"/>
          <p:nvPr/>
        </p:nvSpPr>
        <p:spPr>
          <a:xfrm>
            <a:off x="8008326" y="4835113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F0E2D1D-223F-80E3-7009-FBC7E23C06FB}"/>
              </a:ext>
            </a:extLst>
          </p:cNvPr>
          <p:cNvSpPr txBox="1"/>
          <p:nvPr/>
        </p:nvSpPr>
        <p:spPr>
          <a:xfrm>
            <a:off x="8313896" y="4833184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4906918-2746-80D8-2136-F85882993668}"/>
              </a:ext>
            </a:extLst>
          </p:cNvPr>
          <p:cNvSpPr txBox="1"/>
          <p:nvPr/>
        </p:nvSpPr>
        <p:spPr>
          <a:xfrm>
            <a:off x="8575804" y="4835113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E4F084E-EE7A-0A60-E415-73A548DF7F53}"/>
              </a:ext>
            </a:extLst>
          </p:cNvPr>
          <p:cNvSpPr txBox="1"/>
          <p:nvPr/>
        </p:nvSpPr>
        <p:spPr>
          <a:xfrm>
            <a:off x="8881374" y="4831255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D8DD07F-7339-D615-9BF1-7B196626A137}"/>
              </a:ext>
            </a:extLst>
          </p:cNvPr>
          <p:cNvSpPr txBox="1"/>
          <p:nvPr/>
        </p:nvSpPr>
        <p:spPr>
          <a:xfrm>
            <a:off x="9143282" y="4833184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A64B65B-7A5C-25B4-68DB-2FC4158E135B}"/>
              </a:ext>
            </a:extLst>
          </p:cNvPr>
          <p:cNvSpPr txBox="1"/>
          <p:nvPr/>
        </p:nvSpPr>
        <p:spPr>
          <a:xfrm>
            <a:off x="9442172" y="4823539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0129368-F4CD-5684-FD5D-83B1890A6618}"/>
              </a:ext>
            </a:extLst>
          </p:cNvPr>
          <p:cNvSpPr txBox="1"/>
          <p:nvPr/>
        </p:nvSpPr>
        <p:spPr>
          <a:xfrm>
            <a:off x="9704080" y="4825468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56AB98B-9581-B1DC-0CC3-703A9BCC472A}"/>
              </a:ext>
            </a:extLst>
          </p:cNvPr>
          <p:cNvSpPr txBox="1"/>
          <p:nvPr/>
        </p:nvSpPr>
        <p:spPr>
          <a:xfrm>
            <a:off x="10039762" y="4823419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̶</a:t>
            </a:r>
            <a:endParaRPr lang="en-ZA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0CAFE83-F9F6-59D1-9469-580B737C5350}"/>
              </a:ext>
            </a:extLst>
          </p:cNvPr>
          <p:cNvSpPr txBox="1"/>
          <p:nvPr/>
        </p:nvSpPr>
        <p:spPr>
          <a:xfrm>
            <a:off x="10301670" y="4825348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/>
              <a:t>+</a:t>
            </a:r>
            <a:endParaRPr lang="en-ZA" dirty="0"/>
          </a:p>
        </p:txBody>
      </p:sp>
      <p:pic>
        <p:nvPicPr>
          <p:cNvPr id="6" name="Picture 11" descr="A picture containing text&#10;&#10;Description automatically generated">
            <a:extLst>
              <a:ext uri="{FF2B5EF4-FFF2-40B4-BE49-F238E27FC236}">
                <a16:creationId xmlns:a16="http://schemas.microsoft.com/office/drawing/2014/main" id="{CBE10A3E-0953-3C45-131D-6297B09E45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59230" y="5048920"/>
            <a:ext cx="3482440" cy="1149946"/>
          </a:xfrm>
          <a:prstGeom prst="rect">
            <a:avLst/>
          </a:prstGeom>
        </p:spPr>
      </p:pic>
      <p:pic>
        <p:nvPicPr>
          <p:cNvPr id="14" name="Picture 14" descr="Background pattern&#10;&#10;Description automatically generated">
            <a:extLst>
              <a:ext uri="{FF2B5EF4-FFF2-40B4-BE49-F238E27FC236}">
                <a16:creationId xmlns:a16="http://schemas.microsoft.com/office/drawing/2014/main" id="{137DD8A4-88AE-7701-1D03-DEC80A0C346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10484" y="5030435"/>
            <a:ext cx="3417461" cy="1178825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D6944DD-96E2-CC8F-0AE2-E3514E7B308A}"/>
              </a:ext>
            </a:extLst>
          </p:cNvPr>
          <p:cNvSpPr txBox="1"/>
          <p:nvPr/>
        </p:nvSpPr>
        <p:spPr>
          <a:xfrm>
            <a:off x="858640" y="5798149"/>
            <a:ext cx="103876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b="1" dirty="0">
                <a:cs typeface="Calibri"/>
              </a:rPr>
              <a:t>Total prote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616D026-47B3-7FCF-C1C4-F9B14D6C119B}"/>
              </a:ext>
            </a:extLst>
          </p:cNvPr>
          <p:cNvSpPr txBox="1"/>
          <p:nvPr/>
        </p:nvSpPr>
        <p:spPr>
          <a:xfrm>
            <a:off x="6628672" y="5798148"/>
            <a:ext cx="103876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b="1" dirty="0">
                <a:cs typeface="Calibri"/>
              </a:rPr>
              <a:t>Total protein</a:t>
            </a:r>
          </a:p>
        </p:txBody>
      </p:sp>
    </p:spTree>
    <p:extLst>
      <p:ext uri="{BB962C8B-B14F-4D97-AF65-F5344CB8AC3E}">
        <p14:creationId xmlns:p14="http://schemas.microsoft.com/office/powerpoint/2010/main" val="27799941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tree, green, dark, night sky&#10;&#10;Description automatically generated">
            <a:extLst>
              <a:ext uri="{FF2B5EF4-FFF2-40B4-BE49-F238E27FC236}">
                <a16:creationId xmlns:a16="http://schemas.microsoft.com/office/drawing/2014/main" id="{F11F8FFA-4BC0-FE7F-F277-CB3D3962F89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15" t="22551" r="7135" b="7320"/>
          <a:stretch/>
        </p:blipFill>
        <p:spPr>
          <a:xfrm>
            <a:off x="2768079" y="427619"/>
            <a:ext cx="2442256" cy="2438013"/>
          </a:xfrm>
          <a:prstGeom prst="rect">
            <a:avLst/>
          </a:prstGeom>
        </p:spPr>
      </p:pic>
      <p:pic>
        <p:nvPicPr>
          <p:cNvPr id="9" name="Picture 8" descr="A picture containing tree, star, dark, outdoor object&#10;&#10;Description automatically generated">
            <a:extLst>
              <a:ext uri="{FF2B5EF4-FFF2-40B4-BE49-F238E27FC236}">
                <a16:creationId xmlns:a16="http://schemas.microsoft.com/office/drawing/2014/main" id="{2B956352-83A3-2509-F0F9-D5B15C935EA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57" t="24802" r="7192" b="5071"/>
          <a:stretch/>
        </p:blipFill>
        <p:spPr>
          <a:xfrm>
            <a:off x="5414305" y="427619"/>
            <a:ext cx="2442256" cy="2438013"/>
          </a:xfrm>
          <a:prstGeom prst="rect">
            <a:avLst/>
          </a:prstGeom>
        </p:spPr>
      </p:pic>
      <p:pic>
        <p:nvPicPr>
          <p:cNvPr id="11" name="Picture 10" descr="A picture containing tree, outdoor, dark, star&#10;&#10;Description automatically generated">
            <a:extLst>
              <a:ext uri="{FF2B5EF4-FFF2-40B4-BE49-F238E27FC236}">
                <a16:creationId xmlns:a16="http://schemas.microsoft.com/office/drawing/2014/main" id="{7DBE772D-A779-65EE-979C-0CF10ED3BF0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58" t="24301" r="8692" b="5571"/>
          <a:stretch/>
        </p:blipFill>
        <p:spPr>
          <a:xfrm>
            <a:off x="8060531" y="427619"/>
            <a:ext cx="2442256" cy="2438013"/>
          </a:xfrm>
          <a:prstGeom prst="rect">
            <a:avLst/>
          </a:prstGeom>
        </p:spPr>
      </p:pic>
      <p:pic>
        <p:nvPicPr>
          <p:cNvPr id="19" name="Picture 18" descr="Red fireworks in the night sky&#10;&#10;Description automatically generated">
            <a:extLst>
              <a:ext uri="{FF2B5EF4-FFF2-40B4-BE49-F238E27FC236}">
                <a16:creationId xmlns:a16="http://schemas.microsoft.com/office/drawing/2014/main" id="{BC1F48B0-7253-E118-86D6-FD6B0A77063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75" t="13470" r="14875" b="16402"/>
          <a:stretch/>
        </p:blipFill>
        <p:spPr>
          <a:xfrm>
            <a:off x="5414305" y="3009899"/>
            <a:ext cx="2442256" cy="2438013"/>
          </a:xfrm>
          <a:prstGeom prst="rect">
            <a:avLst/>
          </a:prstGeom>
        </p:spPr>
      </p:pic>
      <p:pic>
        <p:nvPicPr>
          <p:cNvPr id="20" name="Picture 19" descr="A firework display in the night sky&#10;&#10;Description automatically generated with low confidence">
            <a:extLst>
              <a:ext uri="{FF2B5EF4-FFF2-40B4-BE49-F238E27FC236}">
                <a16:creationId xmlns:a16="http://schemas.microsoft.com/office/drawing/2014/main" id="{83D5FEC1-39AF-7468-063F-D66E8BB4C14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75" t="14936" r="11375" b="14936"/>
          <a:stretch/>
        </p:blipFill>
        <p:spPr>
          <a:xfrm>
            <a:off x="8060531" y="3009899"/>
            <a:ext cx="2442256" cy="2438013"/>
          </a:xfrm>
          <a:prstGeom prst="rect">
            <a:avLst/>
          </a:prstGeom>
        </p:spPr>
      </p:pic>
      <p:pic>
        <p:nvPicPr>
          <p:cNvPr id="21" name="Picture 20" descr="A picture containing tree, green, night sky&#10;&#10;Description automatically generated">
            <a:extLst>
              <a:ext uri="{FF2B5EF4-FFF2-40B4-BE49-F238E27FC236}">
                <a16:creationId xmlns:a16="http://schemas.microsoft.com/office/drawing/2014/main" id="{4D802657-E74D-B234-8541-6594E676146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25" t="14936" r="11624" b="14936"/>
          <a:stretch/>
        </p:blipFill>
        <p:spPr>
          <a:xfrm>
            <a:off x="2768079" y="3009899"/>
            <a:ext cx="2442256" cy="2438013"/>
          </a:xfrm>
          <a:prstGeom prst="rect">
            <a:avLst/>
          </a:prstGeom>
        </p:spPr>
      </p:pic>
      <p:pic>
        <p:nvPicPr>
          <p:cNvPr id="22" name="Picture 21" descr="A picture containing tree, star, dark, night&#10;&#10;Description automatically generated">
            <a:extLst>
              <a:ext uri="{FF2B5EF4-FFF2-40B4-BE49-F238E27FC236}">
                <a16:creationId xmlns:a16="http://schemas.microsoft.com/office/drawing/2014/main" id="{EF63ED1B-A2CF-0BAB-7035-CA8A48FCE45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75" t="14936" r="14875" b="14936"/>
          <a:stretch/>
        </p:blipFill>
        <p:spPr>
          <a:xfrm>
            <a:off x="8060531" y="5592178"/>
            <a:ext cx="2442256" cy="2438013"/>
          </a:xfrm>
          <a:prstGeom prst="rect">
            <a:avLst/>
          </a:prstGeom>
        </p:spPr>
      </p:pic>
      <p:pic>
        <p:nvPicPr>
          <p:cNvPr id="23" name="Picture 22" descr="A picture containing tree, green, night sky&#10;&#10;Description automatically generated">
            <a:extLst>
              <a:ext uri="{FF2B5EF4-FFF2-40B4-BE49-F238E27FC236}">
                <a16:creationId xmlns:a16="http://schemas.microsoft.com/office/drawing/2014/main" id="{50EAD349-260D-19B1-8CBE-2DB2210B6583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75" t="11936" r="14875" b="17936"/>
          <a:stretch/>
        </p:blipFill>
        <p:spPr>
          <a:xfrm>
            <a:off x="2768079" y="5592179"/>
            <a:ext cx="2442256" cy="2438013"/>
          </a:xfrm>
          <a:prstGeom prst="rect">
            <a:avLst/>
          </a:prstGeom>
        </p:spPr>
      </p:pic>
      <p:pic>
        <p:nvPicPr>
          <p:cNvPr id="24" name="Picture 23" descr="Red lights in the dark&#10;&#10;Description automatically generated with medium confidence">
            <a:extLst>
              <a:ext uri="{FF2B5EF4-FFF2-40B4-BE49-F238E27FC236}">
                <a16:creationId xmlns:a16="http://schemas.microsoft.com/office/drawing/2014/main" id="{11384583-B670-43C5-FFF2-5F7D37E6BCAC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75" t="14936" r="14875" b="14936"/>
          <a:stretch/>
        </p:blipFill>
        <p:spPr>
          <a:xfrm>
            <a:off x="5414305" y="5592179"/>
            <a:ext cx="2442256" cy="2438013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513738C-82E4-3EC5-9B6C-727A74988425}"/>
              </a:ext>
            </a:extLst>
          </p:cNvPr>
          <p:cNvSpPr txBox="1"/>
          <p:nvPr/>
        </p:nvSpPr>
        <p:spPr>
          <a:xfrm>
            <a:off x="1931855" y="1422400"/>
            <a:ext cx="489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 err="1"/>
              <a:t>Baf</a:t>
            </a:r>
            <a:endParaRPr lang="en-ZA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010E594-8B48-2C87-DBA9-A694686C459A}"/>
              </a:ext>
            </a:extLst>
          </p:cNvPr>
          <p:cNvSpPr txBox="1"/>
          <p:nvPr/>
        </p:nvSpPr>
        <p:spPr>
          <a:xfrm>
            <a:off x="1470283" y="6509321"/>
            <a:ext cx="1093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 err="1"/>
              <a:t>CCCP+Baf</a:t>
            </a:r>
            <a:endParaRPr lang="en-ZA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9A5500F-FA66-646C-949A-156298BE70CF}"/>
              </a:ext>
            </a:extLst>
          </p:cNvPr>
          <p:cNvSpPr txBox="1"/>
          <p:nvPr/>
        </p:nvSpPr>
        <p:spPr>
          <a:xfrm>
            <a:off x="1572268" y="3965860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CCCP</a:t>
            </a:r>
          </a:p>
        </p:txBody>
      </p:sp>
      <p:pic>
        <p:nvPicPr>
          <p:cNvPr id="2" name="Picture 1" descr="A picture containing tree, green, night sky&#10;&#10;Description automatically generated">
            <a:extLst>
              <a:ext uri="{FF2B5EF4-FFF2-40B4-BE49-F238E27FC236}">
                <a16:creationId xmlns:a16="http://schemas.microsoft.com/office/drawing/2014/main" id="{187E0838-8F80-A1EA-3B40-CCA31346D8B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726" t="29007" r="30687" b="53107"/>
          <a:stretch/>
        </p:blipFill>
        <p:spPr>
          <a:xfrm>
            <a:off x="4225008" y="4499769"/>
            <a:ext cx="985327" cy="948143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1E19D5F4-EF77-BEA2-77E7-5255799A0FC5}"/>
              </a:ext>
            </a:extLst>
          </p:cNvPr>
          <p:cNvSpPr/>
          <p:nvPr/>
        </p:nvSpPr>
        <p:spPr>
          <a:xfrm>
            <a:off x="3810480" y="3475584"/>
            <a:ext cx="658368" cy="55850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1649432-C38B-03A5-3A75-5A22BA59196E}"/>
              </a:ext>
            </a:extLst>
          </p:cNvPr>
          <p:cNvSpPr/>
          <p:nvPr/>
        </p:nvSpPr>
        <p:spPr>
          <a:xfrm>
            <a:off x="6635433" y="3475584"/>
            <a:ext cx="658368" cy="55850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A2E5F3B-D8B0-D13F-414A-1148E9A3E52C}"/>
              </a:ext>
            </a:extLst>
          </p:cNvPr>
          <p:cNvSpPr/>
          <p:nvPr/>
        </p:nvSpPr>
        <p:spPr>
          <a:xfrm>
            <a:off x="9101764" y="3474117"/>
            <a:ext cx="658368" cy="55850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pic>
        <p:nvPicPr>
          <p:cNvPr id="6" name="Picture 5" descr="Red fireworks in the night sky&#10;&#10;Description automatically generated">
            <a:extLst>
              <a:ext uri="{FF2B5EF4-FFF2-40B4-BE49-F238E27FC236}">
                <a16:creationId xmlns:a16="http://schemas.microsoft.com/office/drawing/2014/main" id="{CEB051C1-AFB4-05F7-042F-98E6D9364BE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26823" r="31062" b="57112"/>
          <a:stretch/>
        </p:blipFill>
        <p:spPr>
          <a:xfrm>
            <a:off x="6738878" y="4499769"/>
            <a:ext cx="1117683" cy="948143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8" name="Picture 7" descr="A firework display in the night sky&#10;&#10;Description automatically generated with low confidence">
            <a:extLst>
              <a:ext uri="{FF2B5EF4-FFF2-40B4-BE49-F238E27FC236}">
                <a16:creationId xmlns:a16="http://schemas.microsoft.com/office/drawing/2014/main" id="{A0911D7C-AAEA-9C79-D0BA-5F0B71A13A4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325" t="28289" r="32738" b="55646"/>
          <a:stretch/>
        </p:blipFill>
        <p:spPr>
          <a:xfrm>
            <a:off x="9368959" y="4496837"/>
            <a:ext cx="1121142" cy="951076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34F88FFA-F73B-3F00-7A5A-98CD886488F9}"/>
              </a:ext>
            </a:extLst>
          </p:cNvPr>
          <p:cNvSpPr/>
          <p:nvPr/>
        </p:nvSpPr>
        <p:spPr>
          <a:xfrm>
            <a:off x="4017744" y="1219831"/>
            <a:ext cx="651792" cy="57190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91A206C-534A-A05E-D669-7F34DEFBF0DA}"/>
              </a:ext>
            </a:extLst>
          </p:cNvPr>
          <p:cNvSpPr/>
          <p:nvPr/>
        </p:nvSpPr>
        <p:spPr>
          <a:xfrm>
            <a:off x="6635433" y="1219830"/>
            <a:ext cx="651792" cy="57190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E68CB25-3C20-C783-ABAE-6B1FA55AB37A}"/>
              </a:ext>
            </a:extLst>
          </p:cNvPr>
          <p:cNvSpPr/>
          <p:nvPr/>
        </p:nvSpPr>
        <p:spPr>
          <a:xfrm>
            <a:off x="9368959" y="1219830"/>
            <a:ext cx="651792" cy="57190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pic>
        <p:nvPicPr>
          <p:cNvPr id="14" name="Picture 13" descr="A picture containing tree, green, dark, night sky&#10;&#10;Description automatically generated">
            <a:extLst>
              <a:ext uri="{FF2B5EF4-FFF2-40B4-BE49-F238E27FC236}">
                <a16:creationId xmlns:a16="http://schemas.microsoft.com/office/drawing/2014/main" id="{033AABEA-3D87-47AE-4838-4227DF10DEE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61" t="45339" r="22691" b="38211"/>
          <a:stretch/>
        </p:blipFill>
        <p:spPr>
          <a:xfrm>
            <a:off x="4225008" y="2001078"/>
            <a:ext cx="985327" cy="86455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5" name="Picture 14" descr="A picture containing tree, star, dark, outdoor object&#10;&#10;Description automatically generated">
            <a:extLst>
              <a:ext uri="{FF2B5EF4-FFF2-40B4-BE49-F238E27FC236}">
                <a16:creationId xmlns:a16="http://schemas.microsoft.com/office/drawing/2014/main" id="{C203DCA0-885C-4E05-74A3-E2BD7A5F473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682" t="47590" r="23569" b="35960"/>
          <a:stretch/>
        </p:blipFill>
        <p:spPr>
          <a:xfrm>
            <a:off x="6889760" y="2001079"/>
            <a:ext cx="966801" cy="84829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6" name="Picture 15" descr="A picture containing tree, outdoor, dark, star&#10;&#10;Description automatically generated">
            <a:extLst>
              <a:ext uri="{FF2B5EF4-FFF2-40B4-BE49-F238E27FC236}">
                <a16:creationId xmlns:a16="http://schemas.microsoft.com/office/drawing/2014/main" id="{8BECA593-B3E7-2B2F-8BC3-0DA30D11378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94" t="47160" r="22558" b="36390"/>
          <a:stretch/>
        </p:blipFill>
        <p:spPr>
          <a:xfrm>
            <a:off x="9504774" y="2001078"/>
            <a:ext cx="985327" cy="864554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F44417E6-CDD0-A61D-7C6A-C3D2DBEC4A89}"/>
              </a:ext>
            </a:extLst>
          </p:cNvPr>
          <p:cNvSpPr/>
          <p:nvPr/>
        </p:nvSpPr>
        <p:spPr>
          <a:xfrm>
            <a:off x="3330839" y="6811184"/>
            <a:ext cx="658368" cy="55850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BEB4A40-EECD-D643-51B0-82E061029227}"/>
              </a:ext>
            </a:extLst>
          </p:cNvPr>
          <p:cNvSpPr/>
          <p:nvPr/>
        </p:nvSpPr>
        <p:spPr>
          <a:xfrm>
            <a:off x="5977065" y="6811184"/>
            <a:ext cx="658368" cy="55850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F1FFFAA-93DB-6B72-3887-B5DC88D08BE3}"/>
              </a:ext>
            </a:extLst>
          </p:cNvPr>
          <p:cNvSpPr/>
          <p:nvPr/>
        </p:nvSpPr>
        <p:spPr>
          <a:xfrm>
            <a:off x="8583417" y="6811183"/>
            <a:ext cx="658368" cy="55850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pic>
        <p:nvPicPr>
          <p:cNvPr id="29" name="Picture 28" descr="A picture containing tree, green, night sky&#10;&#10;Description automatically generated">
            <a:extLst>
              <a:ext uri="{FF2B5EF4-FFF2-40B4-BE49-F238E27FC236}">
                <a16:creationId xmlns:a16="http://schemas.microsoft.com/office/drawing/2014/main" id="{6E14BC5E-AE14-5097-BEA4-83A09DC2A5C1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62" t="47001" r="50000" b="36935"/>
          <a:stretch/>
        </p:blipFill>
        <p:spPr>
          <a:xfrm>
            <a:off x="4137541" y="7120128"/>
            <a:ext cx="1072794" cy="910063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0" name="Picture 29" descr="Red lights in the dark&#10;&#10;Description automatically generated with medium confidence">
            <a:extLst>
              <a:ext uri="{FF2B5EF4-FFF2-40B4-BE49-F238E27FC236}">
                <a16:creationId xmlns:a16="http://schemas.microsoft.com/office/drawing/2014/main" id="{7AE4D651-088D-54F3-6139-479207A02BB7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62" t="50000" r="50000" b="33935"/>
          <a:stretch/>
        </p:blipFill>
        <p:spPr>
          <a:xfrm>
            <a:off x="6783767" y="7120128"/>
            <a:ext cx="1072794" cy="910063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1" name="Picture 30" descr="A picture containing tree, star, dark, night&#10;&#10;Description automatically generated">
            <a:extLst>
              <a:ext uri="{FF2B5EF4-FFF2-40B4-BE49-F238E27FC236}">
                <a16:creationId xmlns:a16="http://schemas.microsoft.com/office/drawing/2014/main" id="{215D20FB-19FA-A84A-403C-3EF820286DC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15" t="50000" r="51601" b="33935"/>
          <a:stretch/>
        </p:blipFill>
        <p:spPr>
          <a:xfrm>
            <a:off x="9442991" y="7120128"/>
            <a:ext cx="1047110" cy="910063"/>
          </a:xfrm>
          <a:prstGeom prst="rect">
            <a:avLst/>
          </a:prstGeom>
          <a:ln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2385613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43</TotalTime>
  <Words>134</Words>
  <Application>Microsoft Office PowerPoint</Application>
  <PresentationFormat>Custom</PresentationFormat>
  <Paragraphs>4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 Wet, S, Mnr [sdewet@sun.ac.za]</dc:creator>
  <cp:lastModifiedBy>MDPI</cp:lastModifiedBy>
  <cp:revision>101</cp:revision>
  <dcterms:created xsi:type="dcterms:W3CDTF">2022-12-09T12:05:05Z</dcterms:created>
  <dcterms:modified xsi:type="dcterms:W3CDTF">2023-06-27T06:52:50Z</dcterms:modified>
</cp:coreProperties>
</file>